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6800850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102AE-5C21-4FAA-A396-34FBBD33BD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E97BC-BEB5-499D-AAF1-BAD6F96DC8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8D8A7-D5F7-4104-8F72-2ACA735177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4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16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4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16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D2DB5-E45C-47C4-A86F-F686A141F0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2E2FD-674C-449C-9907-F97AA00FF8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4A380-31DF-4373-9E61-557E04694C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3BBED-E67C-48F7-9847-FAAEA04E73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5F2E4-0E80-460B-B9DE-C6DD992835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400"/>
            <a:ext cx="6804000" cy="825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7B4F8-0761-471E-9001-AE056641BF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8DE7D-A049-47A5-8D37-5BAE0F2038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B59B16-06ED-4CEC-92E0-9AAF2AE4D3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F9C97-114F-4B87-8A80-BBD31CBF4E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09000"/>
            <a:ext cx="176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2640" y="9909000"/>
            <a:ext cx="239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909000"/>
            <a:ext cx="176400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Arial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3C4779C-7675-453D-8A0D-ABB223B1893E}" type="slidenum">
              <a:rPr b="0" lang="en-US" sz="1200" spc="-1" strike="noStrike">
                <a:solidFill>
                  <a:srgbClr val="898989"/>
                </a:solidFill>
                <a:latin typeface="Arial"/>
                <a:ea typeface="MS PGothic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6"/>
          <p:cNvSpPr/>
          <p:nvPr/>
        </p:nvSpPr>
        <p:spPr>
          <a:xfrm>
            <a:off x="38160" y="573120"/>
            <a:ext cx="33300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2" name="グループ化 9"/>
          <p:cNvGrpSpPr/>
          <p:nvPr/>
        </p:nvGrpSpPr>
        <p:grpSpPr>
          <a:xfrm>
            <a:off x="486000" y="3225960"/>
            <a:ext cx="2479680" cy="291960"/>
            <a:chOff x="486000" y="3225960"/>
            <a:chExt cx="2479680" cy="291960"/>
          </a:xfrm>
        </p:grpSpPr>
        <p:sp>
          <p:nvSpPr>
            <p:cNvPr id="43" name="直線コネクタ 31"/>
            <p:cNvSpPr/>
            <p:nvPr/>
          </p:nvSpPr>
          <p:spPr>
            <a:xfrm>
              <a:off x="48744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" name="直線コネクタ 32"/>
            <p:cNvSpPr/>
            <p:nvPr/>
          </p:nvSpPr>
          <p:spPr>
            <a:xfrm>
              <a:off x="98568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" name="直線コネクタ 33"/>
            <p:cNvSpPr/>
            <p:nvPr/>
          </p:nvSpPr>
          <p:spPr>
            <a:xfrm>
              <a:off x="1486080" y="3295800"/>
              <a:ext cx="466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" name="直線コネクタ 34"/>
            <p:cNvSpPr/>
            <p:nvPr/>
          </p:nvSpPr>
          <p:spPr>
            <a:xfrm>
              <a:off x="198432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" name="直線コネクタ 35"/>
            <p:cNvSpPr/>
            <p:nvPr/>
          </p:nvSpPr>
          <p:spPr>
            <a:xfrm>
              <a:off x="248292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" name="テキスト ボックス 36"/>
            <p:cNvSpPr/>
            <p:nvPr/>
          </p:nvSpPr>
          <p:spPr>
            <a:xfrm>
              <a:off x="486000" y="3225960"/>
              <a:ext cx="546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CpG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" name="テキスト ボックス 37"/>
            <p:cNvSpPr/>
            <p:nvPr/>
          </p:nvSpPr>
          <p:spPr>
            <a:xfrm>
              <a:off x="1012680" y="3225960"/>
              <a:ext cx="5752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RD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" name="テキスト ボックス 38"/>
            <p:cNvSpPr/>
            <p:nvPr/>
          </p:nvSpPr>
          <p:spPr>
            <a:xfrm>
              <a:off x="1496520" y="3225960"/>
              <a:ext cx="5176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LPS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" name="テキスト ボックス 39"/>
            <p:cNvSpPr/>
            <p:nvPr/>
          </p:nvSpPr>
          <p:spPr>
            <a:xfrm>
              <a:off x="1968480" y="3225960"/>
              <a:ext cx="546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am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" name="テキスト ボックス 40"/>
            <p:cNvSpPr/>
            <p:nvPr/>
          </p:nvSpPr>
          <p:spPr>
            <a:xfrm>
              <a:off x="2507760" y="3225960"/>
              <a:ext cx="4579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IC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pic>
        <p:nvPicPr>
          <p:cNvPr id="53" name="Picture 2" descr=""/>
          <p:cNvPicPr/>
          <p:nvPr/>
        </p:nvPicPr>
        <p:blipFill>
          <a:blip r:embed="rId1"/>
          <a:stretch/>
        </p:blipFill>
        <p:spPr>
          <a:xfrm>
            <a:off x="428760" y="695160"/>
            <a:ext cx="2574720" cy="25560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" descr=""/>
          <p:cNvPicPr/>
          <p:nvPr/>
        </p:nvPicPr>
        <p:blipFill>
          <a:blip r:embed="rId2"/>
          <a:stretch/>
        </p:blipFill>
        <p:spPr>
          <a:xfrm>
            <a:off x="3203640" y="706320"/>
            <a:ext cx="2570040" cy="2559240"/>
          </a:xfrm>
          <a:prstGeom prst="rect">
            <a:avLst/>
          </a:prstGeom>
          <a:ln w="0">
            <a:noFill/>
          </a:ln>
        </p:spPr>
      </p:pic>
      <p:grpSp>
        <p:nvGrpSpPr>
          <p:cNvPr id="55" name="グループ化 9"/>
          <p:cNvGrpSpPr/>
          <p:nvPr/>
        </p:nvGrpSpPr>
        <p:grpSpPr>
          <a:xfrm>
            <a:off x="3279960" y="3225960"/>
            <a:ext cx="2479680" cy="291960"/>
            <a:chOff x="3279960" y="3225960"/>
            <a:chExt cx="2479680" cy="291960"/>
          </a:xfrm>
        </p:grpSpPr>
        <p:sp>
          <p:nvSpPr>
            <p:cNvPr id="56" name="直線コネクタ 45"/>
            <p:cNvSpPr/>
            <p:nvPr/>
          </p:nvSpPr>
          <p:spPr>
            <a:xfrm>
              <a:off x="328140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" name="直線コネクタ 46"/>
            <p:cNvSpPr/>
            <p:nvPr/>
          </p:nvSpPr>
          <p:spPr>
            <a:xfrm>
              <a:off x="377964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" name="直線コネクタ 47"/>
            <p:cNvSpPr/>
            <p:nvPr/>
          </p:nvSpPr>
          <p:spPr>
            <a:xfrm>
              <a:off x="4280040" y="3295800"/>
              <a:ext cx="466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" name="直線コネクタ 48"/>
            <p:cNvSpPr/>
            <p:nvPr/>
          </p:nvSpPr>
          <p:spPr>
            <a:xfrm>
              <a:off x="477828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" name="直線コネクタ 49"/>
            <p:cNvSpPr/>
            <p:nvPr/>
          </p:nvSpPr>
          <p:spPr>
            <a:xfrm>
              <a:off x="5276880" y="3295800"/>
              <a:ext cx="46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" name="テキスト ボックス 50"/>
            <p:cNvSpPr/>
            <p:nvPr/>
          </p:nvSpPr>
          <p:spPr>
            <a:xfrm>
              <a:off x="3279960" y="3225960"/>
              <a:ext cx="546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CpG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" name="テキスト ボックス 51"/>
            <p:cNvSpPr/>
            <p:nvPr/>
          </p:nvSpPr>
          <p:spPr>
            <a:xfrm>
              <a:off x="3806640" y="3225960"/>
              <a:ext cx="5752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RD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" name="テキスト ボックス 52"/>
            <p:cNvSpPr/>
            <p:nvPr/>
          </p:nvSpPr>
          <p:spPr>
            <a:xfrm>
              <a:off x="4290480" y="3225960"/>
              <a:ext cx="5176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LPS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" name="テキスト ボックス 53"/>
            <p:cNvSpPr/>
            <p:nvPr/>
          </p:nvSpPr>
          <p:spPr>
            <a:xfrm>
              <a:off x="4762440" y="3225960"/>
              <a:ext cx="546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am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" name="テキスト ボックス 54"/>
            <p:cNvSpPr/>
            <p:nvPr/>
          </p:nvSpPr>
          <p:spPr>
            <a:xfrm>
              <a:off x="5301720" y="3225960"/>
              <a:ext cx="4579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IC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6" name="テキスト ボックス 67"/>
          <p:cNvSpPr/>
          <p:nvPr/>
        </p:nvSpPr>
        <p:spPr>
          <a:xfrm>
            <a:off x="1215720" y="378000"/>
            <a:ext cx="104328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cluster 1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テキスト ボックス 68"/>
          <p:cNvSpPr/>
          <p:nvPr/>
        </p:nvSpPr>
        <p:spPr>
          <a:xfrm>
            <a:off x="4037400" y="378000"/>
            <a:ext cx="104328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cluster 9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68" name="グループ化 7"/>
          <p:cNvGrpSpPr/>
          <p:nvPr/>
        </p:nvGrpSpPr>
        <p:grpSpPr>
          <a:xfrm>
            <a:off x="441360" y="3867120"/>
            <a:ext cx="2556000" cy="2785320"/>
            <a:chOff x="441360" y="3867120"/>
            <a:chExt cx="2556000" cy="2785320"/>
          </a:xfrm>
        </p:grpSpPr>
        <p:pic>
          <p:nvPicPr>
            <p:cNvPr id="69" name="Picture 2" descr=""/>
            <p:cNvPicPr/>
            <p:nvPr/>
          </p:nvPicPr>
          <p:blipFill>
            <a:blip r:embed="rId3"/>
            <a:stretch/>
          </p:blipFill>
          <p:spPr>
            <a:xfrm>
              <a:off x="441360" y="3867120"/>
              <a:ext cx="2556000" cy="25484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0" name="グループ化 8"/>
            <p:cNvGrpSpPr/>
            <p:nvPr/>
          </p:nvGrpSpPr>
          <p:grpSpPr>
            <a:xfrm>
              <a:off x="524880" y="6360480"/>
              <a:ext cx="2452320" cy="291960"/>
              <a:chOff x="524880" y="6360480"/>
              <a:chExt cx="2452320" cy="291960"/>
            </a:xfrm>
          </p:grpSpPr>
          <p:sp>
            <p:nvSpPr>
              <p:cNvPr id="71" name="直線コネクタ 6"/>
              <p:cNvSpPr/>
              <p:nvPr/>
            </p:nvSpPr>
            <p:spPr>
              <a:xfrm>
                <a:off x="526680" y="6430680"/>
                <a:ext cx="46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2" name="直線コネクタ 7"/>
              <p:cNvSpPr/>
              <p:nvPr/>
            </p:nvSpPr>
            <p:spPr>
              <a:xfrm>
                <a:off x="1019160" y="6430680"/>
                <a:ext cx="46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3" name="直線コネクタ 8"/>
              <p:cNvSpPr/>
              <p:nvPr/>
            </p:nvSpPr>
            <p:spPr>
              <a:xfrm>
                <a:off x="1511280" y="6430680"/>
                <a:ext cx="460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4" name="直線コネクタ 9"/>
              <p:cNvSpPr/>
              <p:nvPr/>
            </p:nvSpPr>
            <p:spPr>
              <a:xfrm>
                <a:off x="2003400" y="6430680"/>
                <a:ext cx="460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5" name="直線コネクタ 10"/>
              <p:cNvSpPr/>
              <p:nvPr/>
            </p:nvSpPr>
            <p:spPr>
              <a:xfrm>
                <a:off x="2494080" y="6430680"/>
                <a:ext cx="46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6" name="テキスト ボックス 11"/>
              <p:cNvSpPr/>
              <p:nvPr/>
            </p:nvSpPr>
            <p:spPr>
              <a:xfrm>
                <a:off x="524880" y="6360480"/>
                <a:ext cx="5464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CpG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7" name="テキスト ボックス 12"/>
              <p:cNvSpPr/>
              <p:nvPr/>
            </p:nvSpPr>
            <p:spPr>
              <a:xfrm>
                <a:off x="1044720" y="6360480"/>
                <a:ext cx="5752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GRD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8" name="テキスト ボックス 13"/>
              <p:cNvSpPr/>
              <p:nvPr/>
            </p:nvSpPr>
            <p:spPr>
              <a:xfrm>
                <a:off x="1521720" y="6360480"/>
                <a:ext cx="5176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LPS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79" name="テキスト ボックス 14"/>
              <p:cNvSpPr/>
              <p:nvPr/>
            </p:nvSpPr>
            <p:spPr>
              <a:xfrm>
                <a:off x="1986840" y="6360480"/>
                <a:ext cx="5464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Pam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0" name="テキスト ボックス 15"/>
              <p:cNvSpPr/>
              <p:nvPr/>
            </p:nvSpPr>
            <p:spPr>
              <a:xfrm>
                <a:off x="2519280" y="6360480"/>
                <a:ext cx="4579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pIC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</p:grpSp>
      <p:grpSp>
        <p:nvGrpSpPr>
          <p:cNvPr id="81" name="グループ化 46"/>
          <p:cNvGrpSpPr/>
          <p:nvPr/>
        </p:nvGrpSpPr>
        <p:grpSpPr>
          <a:xfrm>
            <a:off x="425520" y="7351560"/>
            <a:ext cx="2592360" cy="2841120"/>
            <a:chOff x="425520" y="7351560"/>
            <a:chExt cx="2592360" cy="2841120"/>
          </a:xfrm>
        </p:grpSpPr>
        <p:pic>
          <p:nvPicPr>
            <p:cNvPr id="82" name="Picture 4" descr=""/>
            <p:cNvPicPr/>
            <p:nvPr/>
          </p:nvPicPr>
          <p:blipFill>
            <a:blip r:embed="rId4"/>
            <a:srcRect l="0" t="0" r="981" b="981"/>
            <a:stretch/>
          </p:blipFill>
          <p:spPr>
            <a:xfrm>
              <a:off x="425520" y="7351560"/>
              <a:ext cx="2592360" cy="2592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3" name="グループ化 9"/>
            <p:cNvGrpSpPr/>
            <p:nvPr/>
          </p:nvGrpSpPr>
          <p:grpSpPr>
            <a:xfrm>
              <a:off x="519480" y="9900720"/>
              <a:ext cx="2480760" cy="291960"/>
              <a:chOff x="519480" y="9900720"/>
              <a:chExt cx="2480760" cy="291960"/>
            </a:xfrm>
          </p:grpSpPr>
          <p:sp>
            <p:nvSpPr>
              <p:cNvPr id="84" name="直線コネクタ 20"/>
              <p:cNvSpPr/>
              <p:nvPr/>
            </p:nvSpPr>
            <p:spPr>
              <a:xfrm>
                <a:off x="520200" y="9970920"/>
                <a:ext cx="468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5" name="直線コネクタ 21"/>
              <p:cNvSpPr/>
              <p:nvPr/>
            </p:nvSpPr>
            <p:spPr>
              <a:xfrm>
                <a:off x="1020600" y="9970920"/>
                <a:ext cx="468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6" name="直線コネクタ 22"/>
              <p:cNvSpPr/>
              <p:nvPr/>
            </p:nvSpPr>
            <p:spPr>
              <a:xfrm>
                <a:off x="1519200" y="9970920"/>
                <a:ext cx="468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7" name="直線コネクタ 23"/>
              <p:cNvSpPr/>
              <p:nvPr/>
            </p:nvSpPr>
            <p:spPr>
              <a:xfrm>
                <a:off x="2019240" y="9970920"/>
                <a:ext cx="468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8" name="直線コネクタ 24"/>
              <p:cNvSpPr/>
              <p:nvPr/>
            </p:nvSpPr>
            <p:spPr>
              <a:xfrm>
                <a:off x="2517840" y="9970920"/>
                <a:ext cx="468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89" name="テキスト ボックス 25"/>
              <p:cNvSpPr/>
              <p:nvPr/>
            </p:nvSpPr>
            <p:spPr>
              <a:xfrm>
                <a:off x="519480" y="9900720"/>
                <a:ext cx="5464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CpG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0" name="テキスト ボックス 26"/>
              <p:cNvSpPr/>
              <p:nvPr/>
            </p:nvSpPr>
            <p:spPr>
              <a:xfrm>
                <a:off x="1046880" y="9900720"/>
                <a:ext cx="5752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GRD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1" name="テキスト ボックス 27"/>
              <p:cNvSpPr/>
              <p:nvPr/>
            </p:nvSpPr>
            <p:spPr>
              <a:xfrm>
                <a:off x="1530720" y="9900720"/>
                <a:ext cx="5176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LPS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2" name="テキスト ボックス 28"/>
              <p:cNvSpPr/>
              <p:nvPr/>
            </p:nvSpPr>
            <p:spPr>
              <a:xfrm>
                <a:off x="2002680" y="9900720"/>
                <a:ext cx="54648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Pam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3" name="テキスト ボックス 29"/>
              <p:cNvSpPr/>
              <p:nvPr/>
            </p:nvSpPr>
            <p:spPr>
              <a:xfrm>
                <a:off x="2542320" y="9900720"/>
                <a:ext cx="457920" cy="29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  <a:ea typeface="MS PGothic"/>
                  </a:rPr>
                  <a:t>pIC</a:t>
                </a:r>
                <a:endParaRPr b="0" lang="en-US" sz="14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</p:grpSp>
      <p:pic>
        <p:nvPicPr>
          <p:cNvPr id="94" name="Picture 4" descr=""/>
          <p:cNvPicPr/>
          <p:nvPr/>
        </p:nvPicPr>
        <p:blipFill>
          <a:blip r:embed="rId5"/>
          <a:stretch/>
        </p:blipFill>
        <p:spPr>
          <a:xfrm>
            <a:off x="3195720" y="3849840"/>
            <a:ext cx="2574720" cy="2574720"/>
          </a:xfrm>
          <a:prstGeom prst="rect">
            <a:avLst/>
          </a:prstGeom>
          <a:ln w="0">
            <a:noFill/>
          </a:ln>
        </p:spPr>
      </p:pic>
      <p:grpSp>
        <p:nvGrpSpPr>
          <p:cNvPr id="95" name="グループ化 55"/>
          <p:cNvGrpSpPr/>
          <p:nvPr/>
        </p:nvGrpSpPr>
        <p:grpSpPr>
          <a:xfrm>
            <a:off x="3294000" y="6396120"/>
            <a:ext cx="2480040" cy="291960"/>
            <a:chOff x="3294000" y="6396120"/>
            <a:chExt cx="2480040" cy="291960"/>
          </a:xfrm>
        </p:grpSpPr>
        <p:sp>
          <p:nvSpPr>
            <p:cNvPr id="96" name="直線コネクタ 56"/>
            <p:cNvSpPr/>
            <p:nvPr/>
          </p:nvSpPr>
          <p:spPr>
            <a:xfrm>
              <a:off x="3295440" y="6465960"/>
              <a:ext cx="468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7" name="直線コネクタ 57"/>
            <p:cNvSpPr/>
            <p:nvPr/>
          </p:nvSpPr>
          <p:spPr>
            <a:xfrm>
              <a:off x="3794040" y="6465960"/>
              <a:ext cx="468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8" name="直線コネクタ 58"/>
            <p:cNvSpPr/>
            <p:nvPr/>
          </p:nvSpPr>
          <p:spPr>
            <a:xfrm>
              <a:off x="4294080" y="6465960"/>
              <a:ext cx="466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9" name="直線コネクタ 59"/>
            <p:cNvSpPr/>
            <p:nvPr/>
          </p:nvSpPr>
          <p:spPr>
            <a:xfrm>
              <a:off x="4792680" y="6465960"/>
              <a:ext cx="468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0" name="直線コネクタ 60"/>
            <p:cNvSpPr/>
            <p:nvPr/>
          </p:nvSpPr>
          <p:spPr>
            <a:xfrm>
              <a:off x="5291280" y="6465960"/>
              <a:ext cx="468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1" name="テキスト ボックス 61"/>
            <p:cNvSpPr/>
            <p:nvPr/>
          </p:nvSpPr>
          <p:spPr>
            <a:xfrm>
              <a:off x="3294000" y="6396120"/>
              <a:ext cx="546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CpG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2" name="テキスト ボックス 62"/>
            <p:cNvSpPr/>
            <p:nvPr/>
          </p:nvSpPr>
          <p:spPr>
            <a:xfrm>
              <a:off x="3821040" y="6396120"/>
              <a:ext cx="5752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GRD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3" name="テキスト ボックス 63"/>
            <p:cNvSpPr/>
            <p:nvPr/>
          </p:nvSpPr>
          <p:spPr>
            <a:xfrm>
              <a:off x="4304880" y="6396120"/>
              <a:ext cx="5176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LPS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4" name="テキスト ボックス 64"/>
            <p:cNvSpPr/>
            <p:nvPr/>
          </p:nvSpPr>
          <p:spPr>
            <a:xfrm>
              <a:off x="4776480" y="6396120"/>
              <a:ext cx="54648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am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5" name="テキスト ボックス 65"/>
            <p:cNvSpPr/>
            <p:nvPr/>
          </p:nvSpPr>
          <p:spPr>
            <a:xfrm>
              <a:off x="5316120" y="6396120"/>
              <a:ext cx="4579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MS PGothic"/>
                </a:rPr>
                <a:t>pIC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06" name="テキスト ボックス 66"/>
          <p:cNvSpPr/>
          <p:nvPr/>
        </p:nvSpPr>
        <p:spPr>
          <a:xfrm>
            <a:off x="81720" y="3768840"/>
            <a:ext cx="33300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7" name="テキスト ボックス 69"/>
          <p:cNvSpPr/>
          <p:nvPr/>
        </p:nvSpPr>
        <p:spPr>
          <a:xfrm>
            <a:off x="3929760" y="3546360"/>
            <a:ext cx="116964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cluster 13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テキスト ボックス 70"/>
          <p:cNvSpPr/>
          <p:nvPr/>
        </p:nvSpPr>
        <p:spPr>
          <a:xfrm>
            <a:off x="1216800" y="3546360"/>
            <a:ext cx="116964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cluster 12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9" name="テキスト ボックス 71"/>
          <p:cNvSpPr/>
          <p:nvPr/>
        </p:nvSpPr>
        <p:spPr>
          <a:xfrm>
            <a:off x="1131120" y="7074000"/>
            <a:ext cx="116964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MS PGothic"/>
              </a:rPr>
              <a:t>cluster 14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09:27:06Z</dcterms:created>
  <dc:creator>Alexis Vandenbon</dc:creator>
  <dc:description/>
  <dc:language>en-US</dc:language>
  <cp:lastModifiedBy>alexvdb</cp:lastModifiedBy>
  <dcterms:modified xsi:type="dcterms:W3CDTF">2012-03-21T13:17:14Z</dcterms:modified>
  <cp:revision>219</cp:revision>
  <dc:subject/>
  <dc:title>スライド 1</dc:title>
</cp:coreProperties>
</file>